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sldIdLst>
    <p:sldId id="261" r:id="rId2"/>
    <p:sldId id="256" r:id="rId3"/>
  </p:sldIdLst>
  <p:sldSz cx="12192000" cy="6858000"/>
  <p:notesSz cx="6858000" cy="9144000"/>
  <p:defaultTextStyle>
    <a:defPPr lvl="0">
      <a:defRPr lang="zh-CN"/>
    </a:defPPr>
    <a:lvl1pPr marL="0" lv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lvl="1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lvl="2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lvl="3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lvl="4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lvl="5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lvl="6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lvl="7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lvl="8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31"/>
    <p:restoredTop sz="94732"/>
  </p:normalViewPr>
  <p:slideViewPr>
    <p:cSldViewPr snapToGrid="0">
      <p:cViewPr varScale="1">
        <p:scale>
          <a:sx n="74" d="100"/>
          <a:sy n="74" d="100"/>
        </p:scale>
        <p:origin x="176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156A8-B490-4D7E-92A0-64A1518DEAC4}" type="datetimeFigureOut">
              <a:rPr lang="zh-CN" altLang="en-US" smtClean="0"/>
              <a:t>2024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97D9E-645C-4AEC-97AE-399D980DAC8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image" Target="../media/image4.png"/><Relationship Id="rId5" Type="http://schemas.openxmlformats.org/officeDocument/2006/relationships/tags" Target="../tags/tag5.xml"/><Relationship Id="rId10" Type="http://schemas.openxmlformats.org/officeDocument/2006/relationships/image" Target="../media/image3.jpeg"/><Relationship Id="rId4" Type="http://schemas.openxmlformats.org/officeDocument/2006/relationships/tags" Target="../tags/tag4.xml"/><Relationship Id="rId9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7.png" descr="A close-up of a grey square&#10;&#10;Description automatically generated">
            <a:extLst>
              <a:ext uri="{FF2B5EF4-FFF2-40B4-BE49-F238E27FC236}">
                <a16:creationId xmlns:a16="http://schemas.microsoft.com/office/drawing/2014/main" id="{45EFC5A4-8BB9-0A62-5E59-F01347A4D6A9}"/>
              </a:ext>
            </a:extLst>
          </p:cNvPr>
          <p:cNvPicPr/>
          <p:nvPr/>
        </p:nvPicPr>
        <p:blipFill rotWithShape="1">
          <a:blip r:embed="rId2"/>
          <a:srcRect l="30780" t="32414" r="35300" b="52485"/>
          <a:stretch/>
        </p:blipFill>
        <p:spPr>
          <a:xfrm>
            <a:off x="1756913" y="310552"/>
            <a:ext cx="8678173" cy="4347712"/>
          </a:xfrm>
          <a:prstGeom prst="rect">
            <a:avLst/>
          </a:prstGeom>
          <a:ln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F2933D-705A-32F4-7233-9A6AF62508ED}"/>
              </a:ext>
            </a:extLst>
          </p:cNvPr>
          <p:cNvSpPr txBox="1"/>
          <p:nvPr/>
        </p:nvSpPr>
        <p:spPr>
          <a:xfrm>
            <a:off x="-2875" y="4232351"/>
            <a:ext cx="10837652" cy="13434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marR="0" algn="l">
              <a:spcBef>
                <a:spcPts val="1200"/>
              </a:spcBef>
              <a:spcAft>
                <a:spcPts val="60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 </a:t>
            </a:r>
            <a:endParaRPr lang="en-US" sz="2000" dirty="0">
              <a:effectLst/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endParaRPr>
          </a:p>
          <a:p>
            <a:pPr marL="1656080" marR="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b="1" dirty="0" err="1">
                <a:solidFill>
                  <a:srgbClr val="000000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Supplemetnary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Figure S1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. Identification of primary cerebral endothelial cells.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Primary cerebral endothelial cells were detected with immunofluorescence staining for CD31 (green).</a:t>
            </a:r>
            <a:endParaRPr lang="en-US" sz="2000" dirty="0">
              <a:effectLst/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790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7231E74-EA39-E372-9AB8-A46605FFBA4E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37" t="45334" r="37412" b="45610"/>
          <a:stretch>
            <a:fillRect/>
          </a:stretch>
        </p:blipFill>
        <p:spPr>
          <a:xfrm>
            <a:off x="2597618" y="1946089"/>
            <a:ext cx="3033903" cy="457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D2AC70A-B6BF-E23A-95BF-721D524FEE6F}"/>
              </a:ext>
            </a:extLst>
          </p:cNvPr>
          <p:cNvPicPr>
            <a:picLocks noChangeAspect="1"/>
          </p:cNvPicPr>
          <p:nvPr>
            <p:custDataLst>
              <p:tags r:id="rId2"/>
            </p:custDataLst>
          </p:nvPr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57" t="51062" r="37121" b="40066"/>
          <a:stretch>
            <a:fillRect/>
          </a:stretch>
        </p:blipFill>
        <p:spPr>
          <a:xfrm>
            <a:off x="2597618" y="2641089"/>
            <a:ext cx="3033903" cy="4558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F5EC327-DFAC-A0F9-D86A-69E16E53C7FE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4266010" y="1021912"/>
            <a:ext cx="1277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PS</a:t>
            </a:r>
            <a:endParaRPr lang="zh-CN" altLang="en-US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2834D8DD-E9D0-367C-D6C3-93CD99082715}"/>
              </a:ext>
            </a:extLst>
          </p:cNvPr>
          <p:cNvCxnSpPr>
            <a:cxnSpLocks/>
          </p:cNvCxnSpPr>
          <p:nvPr>
            <p:custDataLst>
              <p:tags r:id="rId4"/>
            </p:custDataLst>
          </p:nvPr>
        </p:nvCxnSpPr>
        <p:spPr>
          <a:xfrm>
            <a:off x="4266010" y="1391244"/>
            <a:ext cx="12777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0F33A6E3-7D70-E6C5-31FF-20420DE52BE3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1553451" y="1979173"/>
            <a:ext cx="1090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-MLC2</a:t>
            </a:r>
            <a:endParaRPr lang="zh-CN" altLang="en-US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BD51D8E-E3D9-5B2E-B921-61FD6EB7FB0D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1738544" y="2684352"/>
            <a:ext cx="1090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LC2</a:t>
            </a:r>
            <a:endParaRPr lang="zh-CN" altLang="en-US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66F9FB0B-FA6C-2D58-4ECE-494DB5C7D70C}"/>
              </a:ext>
            </a:extLst>
          </p:cNvPr>
          <p:cNvCxnSpPr>
            <a:cxnSpLocks/>
          </p:cNvCxnSpPr>
          <p:nvPr>
            <p:custDataLst>
              <p:tags r:id="rId7"/>
            </p:custDataLst>
          </p:nvPr>
        </p:nvCxnSpPr>
        <p:spPr>
          <a:xfrm flipV="1">
            <a:off x="2689946" y="1391244"/>
            <a:ext cx="1316995" cy="36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06DCF2C6-99E5-2D69-D4FC-39237DAAE5BF}"/>
              </a:ext>
            </a:extLst>
          </p:cNvPr>
          <p:cNvSpPr txBox="1"/>
          <p:nvPr/>
        </p:nvSpPr>
        <p:spPr>
          <a:xfrm>
            <a:off x="2871419" y="1021911"/>
            <a:ext cx="1463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1" name="文本框 9">
            <a:extLst>
              <a:ext uri="{FF2B5EF4-FFF2-40B4-BE49-F238E27FC236}">
                <a16:creationId xmlns:a16="http://schemas.microsoft.com/office/drawing/2014/main" id="{3FE05A1D-AD8A-56BA-D143-02C9AFE03641}"/>
              </a:ext>
            </a:extLst>
          </p:cNvPr>
          <p:cNvSpPr txBox="1"/>
          <p:nvPr/>
        </p:nvSpPr>
        <p:spPr>
          <a:xfrm>
            <a:off x="2643464" y="1521847"/>
            <a:ext cx="290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WT      KO      WT      KO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114DE31-F8F5-309F-8490-0BCD7115045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560481" y="204141"/>
            <a:ext cx="3435878" cy="404718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D36A0E1-F2B2-B5DF-8C65-220B9626D4FC}"/>
              </a:ext>
            </a:extLst>
          </p:cNvPr>
          <p:cNvSpPr txBox="1"/>
          <p:nvPr/>
        </p:nvSpPr>
        <p:spPr>
          <a:xfrm>
            <a:off x="1157402" y="4107585"/>
            <a:ext cx="877269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Supplementary Figure S2. LPS-induced MLC2 phosphorylation is attenuated in CXCR2 KO mice brain tissues.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PBS or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LPS (10 mg/kg,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i.p.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)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was administered to WT mice and CXCR2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−/−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mice. 4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hr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later, brain tissues were extracted for western blot analysis. n=4. *, p&lt;0.05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709175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52.1812598425197,&quot;left&quot;:103.47023622047243,&quot;top&quot;:84.09614173228347,&quot;width&quot;:847.326062992126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98</Words>
  <Application>Microsoft Macintosh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Palatino Linotype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Ting Wang</cp:lastModifiedBy>
  <cp:revision>2</cp:revision>
  <dcterms:modified xsi:type="dcterms:W3CDTF">2024-06-21T03:56:57Z</dcterms:modified>
</cp:coreProperties>
</file>